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218238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>
        <p:scale>
          <a:sx n="200" d="100"/>
          <a:sy n="200" d="100"/>
        </p:scale>
        <p:origin x="78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8" y="1272011"/>
            <a:ext cx="5285502" cy="2705947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082310"/>
            <a:ext cx="4663679" cy="1876530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86601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08049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13808"/>
            <a:ext cx="1340808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13808"/>
            <a:ext cx="3944695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95490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79232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1937705"/>
            <a:ext cx="5363230" cy="3233102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201393"/>
            <a:ext cx="5363230" cy="1700212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>
                    <a:tint val="82000"/>
                  </a:schemeClr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82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31537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4" y="2069042"/>
            <a:ext cx="2642751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3" y="2069042"/>
            <a:ext cx="2642751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728023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13810"/>
            <a:ext cx="536323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4" y="1905318"/>
            <a:ext cx="2630606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4" y="2839085"/>
            <a:ext cx="2630606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3" y="1905318"/>
            <a:ext cx="2643561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3" y="2839085"/>
            <a:ext cx="2643561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54868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41289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05548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1" y="1119083"/>
            <a:ext cx="3147983" cy="5523442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58249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1" y="1119083"/>
            <a:ext cx="3147983" cy="5523442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19973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13810"/>
            <a:ext cx="536323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069042"/>
            <a:ext cx="536323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4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2" y="7203865"/>
            <a:ext cx="209865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0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85878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4D44E0B-575E-9853-0B94-CA35536AF3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7133361"/>
              </p:ext>
            </p:extLst>
          </p:nvPr>
        </p:nvGraphicFramePr>
        <p:xfrm>
          <a:off x="411070" y="696818"/>
          <a:ext cx="5468470" cy="695660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73413">
                  <a:extLst>
                    <a:ext uri="{9D8B030D-6E8A-4147-A177-3AD203B41FA5}">
                      <a16:colId xmlns:a16="http://schemas.microsoft.com/office/drawing/2014/main" val="1696768642"/>
                    </a:ext>
                  </a:extLst>
                </a:gridCol>
                <a:gridCol w="412704">
                  <a:extLst>
                    <a:ext uri="{9D8B030D-6E8A-4147-A177-3AD203B41FA5}">
                      <a16:colId xmlns:a16="http://schemas.microsoft.com/office/drawing/2014/main" val="29117911"/>
                    </a:ext>
                  </a:extLst>
                </a:gridCol>
                <a:gridCol w="561788">
                  <a:extLst>
                    <a:ext uri="{9D8B030D-6E8A-4147-A177-3AD203B41FA5}">
                      <a16:colId xmlns:a16="http://schemas.microsoft.com/office/drawing/2014/main" val="1020684437"/>
                    </a:ext>
                  </a:extLst>
                </a:gridCol>
                <a:gridCol w="785913">
                  <a:extLst>
                    <a:ext uri="{9D8B030D-6E8A-4147-A177-3AD203B41FA5}">
                      <a16:colId xmlns:a16="http://schemas.microsoft.com/office/drawing/2014/main" val="1106311079"/>
                    </a:ext>
                  </a:extLst>
                </a:gridCol>
                <a:gridCol w="681445">
                  <a:extLst>
                    <a:ext uri="{9D8B030D-6E8A-4147-A177-3AD203B41FA5}">
                      <a16:colId xmlns:a16="http://schemas.microsoft.com/office/drawing/2014/main" val="3519605333"/>
                    </a:ext>
                  </a:extLst>
                </a:gridCol>
                <a:gridCol w="658731">
                  <a:extLst>
                    <a:ext uri="{9D8B030D-6E8A-4147-A177-3AD203B41FA5}">
                      <a16:colId xmlns:a16="http://schemas.microsoft.com/office/drawing/2014/main" val="3908061784"/>
                    </a:ext>
                  </a:extLst>
                </a:gridCol>
                <a:gridCol w="590588">
                  <a:extLst>
                    <a:ext uri="{9D8B030D-6E8A-4147-A177-3AD203B41FA5}">
                      <a16:colId xmlns:a16="http://schemas.microsoft.com/office/drawing/2014/main" val="3926277162"/>
                    </a:ext>
                  </a:extLst>
                </a:gridCol>
                <a:gridCol w="601944">
                  <a:extLst>
                    <a:ext uri="{9D8B030D-6E8A-4147-A177-3AD203B41FA5}">
                      <a16:colId xmlns:a16="http://schemas.microsoft.com/office/drawing/2014/main" val="1404286770"/>
                    </a:ext>
                  </a:extLst>
                </a:gridCol>
                <a:gridCol w="601944">
                  <a:extLst>
                    <a:ext uri="{9D8B030D-6E8A-4147-A177-3AD203B41FA5}">
                      <a16:colId xmlns:a16="http://schemas.microsoft.com/office/drawing/2014/main" val="2959069016"/>
                    </a:ext>
                  </a:extLst>
                </a:gridCol>
              </a:tblGrid>
              <a:tr h="615846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ll types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 type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N2 copy </a:t>
                      </a:r>
                      <a:r>
                        <a:rPr lang="fr-B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reatment initiation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/FSTN follow-up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llow-up (</a:t>
                      </a:r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 GDF8 (</a:t>
                      </a:r>
                      <a:r>
                        <a:rPr lang="en-US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  <a:b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 (</a:t>
                      </a:r>
                      <a:r>
                        <a:rPr lang="en-US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3509767"/>
                  </a:ext>
                </a:extLst>
              </a:tr>
              <a:tr h="160472">
                <a:tc row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2921581079"/>
                  </a:ext>
                </a:extLst>
              </a:tr>
              <a:tr h="160472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ing</a:t>
                      </a:r>
                      <a:endParaRPr lang="en-US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554781109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6.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9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4136034171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8.9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1042621070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4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1423734512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4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6.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7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2937430021"/>
                  </a:ext>
                </a:extLst>
              </a:tr>
              <a:tr h="160472"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761025"/>
                  </a:ext>
                </a:extLst>
              </a:tr>
              <a:tr h="615846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 Type 1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N2 copy </a:t>
                      </a:r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en-US" sz="9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reatment initiation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/FSTN follow-up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llow-up (</a:t>
                      </a:r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 (</a:t>
                      </a:r>
                      <a:r>
                        <a:rPr lang="en-US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 (</a:t>
                      </a:r>
                      <a:r>
                        <a:rPr lang="fr-BE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3471522"/>
                  </a:ext>
                </a:extLst>
              </a:tr>
              <a:tr h="160472">
                <a:tc row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74973328"/>
                  </a:ext>
                </a:extLst>
              </a:tr>
              <a:tr h="160472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ing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2596214498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6.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0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2699556365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7.8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0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122629899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9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7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426015124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49.1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3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01773537"/>
                  </a:ext>
                </a:extLst>
              </a:tr>
              <a:tr h="160472"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7752470"/>
                  </a:ext>
                </a:extLst>
              </a:tr>
              <a:tr h="615846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 Type 2 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N2 copy </a:t>
                      </a:r>
                      <a:r>
                        <a:rPr lang="fr-BE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reatment initiation (months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/FSTN follow-up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follow-up (months)</a:t>
                      </a:r>
                      <a:endParaRPr lang="fr-B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 (</a:t>
                      </a:r>
                      <a:r>
                        <a:rPr lang="fr-BE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 (</a:t>
                      </a:r>
                      <a:r>
                        <a:rPr lang="fr-BE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1385441"/>
                  </a:ext>
                </a:extLst>
              </a:tr>
              <a:tr h="160472">
                <a:tc row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15078270"/>
                  </a:ext>
                </a:extLst>
              </a:tr>
              <a:tr h="160472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ing</a:t>
                      </a:r>
                      <a:endParaRPr lang="en-US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686689656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.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2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4.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037732588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2.6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460123348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4034053992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9.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7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17150268"/>
                  </a:ext>
                </a:extLst>
              </a:tr>
              <a:tr h="160472"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/>
                </a:tc>
                <a:extLst>
                  <a:ext uri="{0D108BD9-81ED-4DB2-BD59-A6C34878D82A}">
                    <a16:rowId xmlns:a16="http://schemas.microsoft.com/office/drawing/2014/main" val="2146931744"/>
                  </a:ext>
                </a:extLst>
              </a:tr>
              <a:tr h="160472"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750068"/>
                  </a:ext>
                </a:extLst>
              </a:tr>
              <a:tr h="615846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 Type 3 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N2 copy </a:t>
                      </a:r>
                      <a:r>
                        <a:rPr lang="en-US" sz="900" b="1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en-US" sz="9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reatment initiation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/FSTN follow-up (month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follow-up (months)</a:t>
                      </a:r>
                      <a:endParaRPr lang="fr-B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 (</a:t>
                      </a:r>
                      <a:r>
                        <a:rPr lang="fr-BE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  <a:p>
                      <a:pPr algn="ctr" fontAlgn="b"/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 (</a:t>
                      </a:r>
                      <a:r>
                        <a:rPr lang="fr-BE" sz="900" b="1" u="none" strike="noStrike" noProof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fr-B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fr-B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2781385"/>
                  </a:ext>
                </a:extLst>
              </a:tr>
              <a:tr h="160472">
                <a:tc row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19107902"/>
                  </a:ext>
                </a:extLst>
              </a:tr>
              <a:tr h="160472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ing</a:t>
                      </a:r>
                      <a:endParaRPr lang="en-US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1551011128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7.8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0.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9.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3843264816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6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8.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1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423243369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4.8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4.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452448631"/>
                  </a:ext>
                </a:extLst>
              </a:tr>
              <a:tr h="160472">
                <a:tc gridSpan="2">
                  <a:txBody>
                    <a:bodyPr/>
                    <a:lstStyle/>
                    <a:p>
                      <a:pPr algn="l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4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6.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0.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53" marR="2553" marT="2553" marB="0"/>
                </a:tc>
                <a:extLst>
                  <a:ext uri="{0D108BD9-81ED-4DB2-BD59-A6C34878D82A}">
                    <a16:rowId xmlns:a16="http://schemas.microsoft.com/office/drawing/2014/main" val="204895624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5ACCF55-6424-91D4-0882-A41E6A340657}"/>
              </a:ext>
            </a:extLst>
          </p:cNvPr>
          <p:cNvSpPr txBox="1"/>
          <p:nvPr/>
        </p:nvSpPr>
        <p:spPr>
          <a:xfrm>
            <a:off x="291539" y="170890"/>
            <a:ext cx="54266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BE" sz="900" b="1" dirty="0">
                <a:latin typeface="Arial" panose="020B0604020202020204" pitchFamily="34" charset="0"/>
                <a:cs typeface="Arial" panose="020B0604020202020204" pitchFamily="34" charset="0"/>
              </a:rPr>
              <a:t> Table S1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emographics.</a:t>
            </a:r>
            <a:r>
              <a:rPr lang="fr-B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18005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1</Words>
  <Application>Microsoft Office PowerPoint</Application>
  <PresentationFormat>Custom</PresentationFormat>
  <Paragraphs>2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ne Mackels</dc:creator>
  <cp:lastModifiedBy>MDPI-023</cp:lastModifiedBy>
  <cp:revision>47</cp:revision>
  <dcterms:created xsi:type="dcterms:W3CDTF">2024-03-19T13:08:48Z</dcterms:created>
  <dcterms:modified xsi:type="dcterms:W3CDTF">2024-08-09T17:25:23Z</dcterms:modified>
</cp:coreProperties>
</file>